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19" r:id="rId2"/>
    <p:sldId id="420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89" userDrawn="1">
          <p15:clr>
            <a:srgbClr val="A4A3A4"/>
          </p15:clr>
        </p15:guide>
        <p15:guide id="2" pos="1867" userDrawn="1">
          <p15:clr>
            <a:srgbClr val="A4A3A4"/>
          </p15:clr>
        </p15:guide>
        <p15:guide id="3" pos="58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468" y="43"/>
      </p:cViewPr>
      <p:guideLst>
        <p:guide orient="horz" pos="3589"/>
        <p:guide pos="1867"/>
        <p:guide pos="58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043A06B-2A69-7D28-77B9-EC303C7AB8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9F52983-D277-DE62-3239-579B30C674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BA65532-5A8F-D97C-C699-201FC24DC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70756A9-61C6-86A6-9775-D1536E311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BC47977-6BCC-2CAA-763D-4A81CA0080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579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12ACAD-0726-5C06-3A11-3E4034EEDB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338E2A1-7026-2D0E-DDB2-5F8F0D6742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704273B-0967-7EF3-723B-3321DE815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66D58AF-90CF-BD20-2A88-DA9CECD0F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FD941C5-60C8-3C6D-707F-0A1E66CC8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5571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0EC6329-4CCE-8862-3E9C-A84125527F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A18D166-1D9B-60B3-1EA4-7FBB026C2B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DC883A7-6983-9878-13D9-30041AA57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ED6CB5D-9F15-CB70-1C4D-471217256B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7B4E1EC-29FE-8CA8-DE65-2BD4B93DD6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8975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C879C6-3BB9-916C-24D4-CD482F56A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A989310-409B-DA49-A8F4-24AEFE2E0E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651D9D9-7070-C6EE-7B7F-C7D289C2F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5EADD83-55F7-FD3D-E507-AA370F79C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69ABA79-3286-6C36-8235-8C1396483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0587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EB623C2-29A2-C17D-9DB7-15AFDCB043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CC07D46-054B-D171-691E-CD72DF5AE9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17B856C-F5B7-FD38-6FCB-6C1D1FF4E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510BC2-3249-180B-5951-6C741BC30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6B0F47B-73B1-37D6-EA34-FC73D73D44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1051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DC2AB7C-D0FD-4A0E-4DEA-420E834906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B58495E-8FD9-1309-F449-9213B6662B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64C3413-8109-1612-9E68-02037B7F6B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1BE5AE6-5A87-E05B-91B6-75ECFEC4B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765ED79-62BE-8FF4-7B69-FA6AE643E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46D40FF-EBE5-8262-6DB6-2B3B5E2C3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27232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F99F89-FA4A-EFDD-A22B-DEAEDDADB7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A381807-1503-AD3C-C4CD-6DC18338F0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3BED298-3745-894E-C5FE-FC69516B8E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4842AF9B-2115-8709-3358-B2E71621C3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68C9686-C065-832F-B378-B6BAFFA489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E8A706AB-CBA5-AB46-BE12-CFB39819D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8FA690A-0360-01AB-896C-2DC334F250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E93ABD1-89D5-30E6-6AD3-A2C83181F2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8859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888652F-8659-AEE6-156E-3EDB4BC45C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33691ED-A1FD-FA02-6AB8-25CB7B650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899B30D-38C9-B200-5743-A74463BDE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E0BC4CC-3B72-542D-6ACC-ACB26CE6A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0783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2EE0D195-B30F-8CB8-249C-FB245F8CF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C72D6FB1-3610-0B12-5393-650F5375E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3F2AD64-1CFD-58A9-F46E-84BB5559B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9305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323C143-E7A6-DB61-AEFB-5AD8D61EE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7025706-5A52-B27D-CF4D-1F414774D4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C900041-6AE9-08DD-6561-6BEF96B140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679BECD-B518-41D7-C8BB-17CC70D8E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3D4070C-121C-499B-AB67-9DFDC49FE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125D7EC-3D31-F408-673E-053063A1D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4672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A2A41C8-BBA6-2E5D-D066-981C8D8738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DEE27900-2A52-6399-715D-EB0A1C877C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DD51E5D-03E6-B941-B28C-2EB0B96FBF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839CD0D-D02B-AB29-3DF9-D63C3D4AE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84BD0C2-C405-003B-BBCE-0BE5E7BDA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596B715-1C17-9077-4115-C996388906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1811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7F1BF24-AE89-171E-8105-7E8A900164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C8B411B-3A84-F415-0E08-2A8B420413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7BAA4C3-132C-E08F-D689-C34D61BA81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1536B0-3BC3-4EB1-AD86-9FC85C2F74BD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36A7E64-891C-78E3-EEED-E3AFDC50D5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34FC120-BCF8-CF1E-BB2D-5E4EEFEDA6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E5F74-27EA-4895-A108-450059DB2A8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8939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E4447A0-8D4E-5C90-E9A3-48DBFF8E66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2935793" y="1377841"/>
            <a:ext cx="6320414" cy="4312920"/>
          </a:xfrm>
          <a:prstGeom prst="rect">
            <a:avLst/>
          </a:prstGeom>
        </p:spPr>
      </p:pic>
      <p:sp>
        <p:nvSpPr>
          <p:cNvPr id="4" name="CasellaDiTesto 19">
            <a:extLst>
              <a:ext uri="{FF2B5EF4-FFF2-40B4-BE49-F238E27FC236}">
                <a16:creationId xmlns:a16="http://schemas.microsoft.com/office/drawing/2014/main" id="{FB715E80-6743-4FAE-4575-B6A46DDC4625}"/>
              </a:ext>
            </a:extLst>
          </p:cNvPr>
          <p:cNvSpPr txBox="1"/>
          <p:nvPr/>
        </p:nvSpPr>
        <p:spPr>
          <a:xfrm>
            <a:off x="3615640" y="1309872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5" name="CasellaDiTesto 20">
            <a:extLst>
              <a:ext uri="{FF2B5EF4-FFF2-40B4-BE49-F238E27FC236}">
                <a16:creationId xmlns:a16="http://schemas.microsoft.com/office/drawing/2014/main" id="{26D17719-09A4-4482-A64D-4746172FD2F7}"/>
              </a:ext>
            </a:extLst>
          </p:cNvPr>
          <p:cNvSpPr txBox="1"/>
          <p:nvPr/>
        </p:nvSpPr>
        <p:spPr>
          <a:xfrm>
            <a:off x="4348719" y="1309872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6" name="CasellaDiTesto 32">
            <a:extLst>
              <a:ext uri="{FF2B5EF4-FFF2-40B4-BE49-F238E27FC236}">
                <a16:creationId xmlns:a16="http://schemas.microsoft.com/office/drawing/2014/main" id="{CA48010E-76E4-B8A9-63D6-CB69E38C9FA9}"/>
              </a:ext>
            </a:extLst>
          </p:cNvPr>
          <p:cNvSpPr txBox="1"/>
          <p:nvPr/>
        </p:nvSpPr>
        <p:spPr>
          <a:xfrm>
            <a:off x="3890440" y="1039287"/>
            <a:ext cx="75588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" name="CasellaDiTesto 36">
            <a:extLst>
              <a:ext uri="{FF2B5EF4-FFF2-40B4-BE49-F238E27FC236}">
                <a16:creationId xmlns:a16="http://schemas.microsoft.com/office/drawing/2014/main" id="{08487ED0-9CB6-E027-4C23-6FF722755742}"/>
              </a:ext>
            </a:extLst>
          </p:cNvPr>
          <p:cNvSpPr txBox="1"/>
          <p:nvPr/>
        </p:nvSpPr>
        <p:spPr>
          <a:xfrm>
            <a:off x="3436536" y="762287"/>
            <a:ext cx="1592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RSH3</a:t>
            </a:r>
            <a:r>
              <a:rPr lang="it-IT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39-221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8" name="CasellaDiTesto 19">
            <a:extLst>
              <a:ext uri="{FF2B5EF4-FFF2-40B4-BE49-F238E27FC236}">
                <a16:creationId xmlns:a16="http://schemas.microsoft.com/office/drawing/2014/main" id="{A408E85A-D229-691B-A7AC-F05507FE81F1}"/>
              </a:ext>
            </a:extLst>
          </p:cNvPr>
          <p:cNvSpPr txBox="1"/>
          <p:nvPr/>
        </p:nvSpPr>
        <p:spPr>
          <a:xfrm>
            <a:off x="5546599" y="1309871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9" name="CasellaDiTesto 32">
            <a:extLst>
              <a:ext uri="{FF2B5EF4-FFF2-40B4-BE49-F238E27FC236}">
                <a16:creationId xmlns:a16="http://schemas.microsoft.com/office/drawing/2014/main" id="{15FE7997-AF97-DD16-5DC6-121025F74E90}"/>
              </a:ext>
            </a:extLst>
          </p:cNvPr>
          <p:cNvSpPr txBox="1"/>
          <p:nvPr/>
        </p:nvSpPr>
        <p:spPr>
          <a:xfrm>
            <a:off x="5471402" y="1042365"/>
            <a:ext cx="75588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</a:p>
        </p:txBody>
      </p:sp>
      <p:sp>
        <p:nvSpPr>
          <p:cNvPr id="10" name="CasellaDiTesto 36">
            <a:extLst>
              <a:ext uri="{FF2B5EF4-FFF2-40B4-BE49-F238E27FC236}">
                <a16:creationId xmlns:a16="http://schemas.microsoft.com/office/drawing/2014/main" id="{FEF27482-0B09-315C-F603-962FB9D1E03A}"/>
              </a:ext>
            </a:extLst>
          </p:cNvPr>
          <p:cNvSpPr txBox="1"/>
          <p:nvPr/>
        </p:nvSpPr>
        <p:spPr>
          <a:xfrm>
            <a:off x="4892458" y="795940"/>
            <a:ext cx="1592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RSH3</a:t>
            </a:r>
            <a:r>
              <a:rPr lang="it-IT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39-221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11" name="CasellaDiTesto 7">
            <a:extLst>
              <a:ext uri="{FF2B5EF4-FFF2-40B4-BE49-F238E27FC236}">
                <a16:creationId xmlns:a16="http://schemas.microsoft.com/office/drawing/2014/main" id="{3589CC2C-780D-F205-A365-4776D69CA3AD}"/>
              </a:ext>
            </a:extLst>
          </p:cNvPr>
          <p:cNvSpPr txBox="1"/>
          <p:nvPr/>
        </p:nvSpPr>
        <p:spPr>
          <a:xfrm>
            <a:off x="328670" y="365635"/>
            <a:ext cx="1678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>
                <a:latin typeface="Arial" panose="020B0604020202020204" pitchFamily="34" charset="0"/>
                <a:cs typeface="Arial" panose="020B0604020202020204" pitchFamily="34" charset="0"/>
              </a:rPr>
              <a:t>Phos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-tag Anti-GFP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306D291-E613-3BBB-25EF-A8909CD20D2F}"/>
              </a:ext>
            </a:extLst>
          </p:cNvPr>
          <p:cNvSpPr/>
          <p:nvPr/>
        </p:nvSpPr>
        <p:spPr>
          <a:xfrm>
            <a:off x="3664372" y="2830917"/>
            <a:ext cx="1274394" cy="13090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6BA5791-D18E-FE08-623B-6DFDE98BE1A1}"/>
              </a:ext>
            </a:extLst>
          </p:cNvPr>
          <p:cNvSpPr/>
          <p:nvPr/>
        </p:nvSpPr>
        <p:spPr>
          <a:xfrm>
            <a:off x="5458803" y="2830917"/>
            <a:ext cx="652743" cy="13090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20783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8118EF9E-1A59-A41C-7BAA-80B6260EB1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3862" y="990858"/>
            <a:ext cx="6368559" cy="4706680"/>
          </a:xfrm>
          <a:prstGeom prst="rect">
            <a:avLst/>
          </a:prstGeom>
        </p:spPr>
      </p:pic>
      <p:sp>
        <p:nvSpPr>
          <p:cNvPr id="10" name="CasellaDiTesto 19">
            <a:extLst>
              <a:ext uri="{FF2B5EF4-FFF2-40B4-BE49-F238E27FC236}">
                <a16:creationId xmlns:a16="http://schemas.microsoft.com/office/drawing/2014/main" id="{C71E3D9F-C6DB-BF85-F8B4-DCF02884BCC1}"/>
              </a:ext>
            </a:extLst>
          </p:cNvPr>
          <p:cNvSpPr txBox="1"/>
          <p:nvPr/>
        </p:nvSpPr>
        <p:spPr>
          <a:xfrm>
            <a:off x="3732019" y="1309872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1" name="CasellaDiTesto 20">
            <a:extLst>
              <a:ext uri="{FF2B5EF4-FFF2-40B4-BE49-F238E27FC236}">
                <a16:creationId xmlns:a16="http://schemas.microsoft.com/office/drawing/2014/main" id="{B358FF83-BC2A-655B-9BDE-E48D6F03FEE3}"/>
              </a:ext>
            </a:extLst>
          </p:cNvPr>
          <p:cNvSpPr txBox="1"/>
          <p:nvPr/>
        </p:nvSpPr>
        <p:spPr>
          <a:xfrm>
            <a:off x="4465098" y="1309872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AZD</a:t>
            </a:r>
          </a:p>
        </p:txBody>
      </p:sp>
      <p:sp>
        <p:nvSpPr>
          <p:cNvPr id="12" name="CasellaDiTesto 32">
            <a:extLst>
              <a:ext uri="{FF2B5EF4-FFF2-40B4-BE49-F238E27FC236}">
                <a16:creationId xmlns:a16="http://schemas.microsoft.com/office/drawing/2014/main" id="{458465FD-315C-A04D-DCFA-2985F5363893}"/>
              </a:ext>
            </a:extLst>
          </p:cNvPr>
          <p:cNvSpPr txBox="1"/>
          <p:nvPr/>
        </p:nvSpPr>
        <p:spPr>
          <a:xfrm>
            <a:off x="4006819" y="1039287"/>
            <a:ext cx="75588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3" name="CasellaDiTesto 36">
            <a:extLst>
              <a:ext uri="{FF2B5EF4-FFF2-40B4-BE49-F238E27FC236}">
                <a16:creationId xmlns:a16="http://schemas.microsoft.com/office/drawing/2014/main" id="{8065FE1F-C1E6-078B-1865-F93E5003F62D}"/>
              </a:ext>
            </a:extLst>
          </p:cNvPr>
          <p:cNvSpPr txBox="1"/>
          <p:nvPr/>
        </p:nvSpPr>
        <p:spPr>
          <a:xfrm>
            <a:off x="3552915" y="762287"/>
            <a:ext cx="1592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RSH3</a:t>
            </a:r>
            <a:r>
              <a:rPr lang="it-IT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39-221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14" name="CasellaDiTesto 19">
            <a:extLst>
              <a:ext uri="{FF2B5EF4-FFF2-40B4-BE49-F238E27FC236}">
                <a16:creationId xmlns:a16="http://schemas.microsoft.com/office/drawing/2014/main" id="{0B9B138C-BB7C-E3D4-06A8-701A09E9E522}"/>
              </a:ext>
            </a:extLst>
          </p:cNvPr>
          <p:cNvSpPr txBox="1"/>
          <p:nvPr/>
        </p:nvSpPr>
        <p:spPr>
          <a:xfrm>
            <a:off x="5779357" y="1309871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5" name="CasellaDiTesto 32">
            <a:extLst>
              <a:ext uri="{FF2B5EF4-FFF2-40B4-BE49-F238E27FC236}">
                <a16:creationId xmlns:a16="http://schemas.microsoft.com/office/drawing/2014/main" id="{070F7CF1-9ED8-D25A-695F-02C1B24AD113}"/>
              </a:ext>
            </a:extLst>
          </p:cNvPr>
          <p:cNvSpPr txBox="1"/>
          <p:nvPr/>
        </p:nvSpPr>
        <p:spPr>
          <a:xfrm>
            <a:off x="5704160" y="1042365"/>
            <a:ext cx="75588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</a:p>
        </p:txBody>
      </p:sp>
      <p:sp>
        <p:nvSpPr>
          <p:cNvPr id="16" name="CasellaDiTesto 36">
            <a:extLst>
              <a:ext uri="{FF2B5EF4-FFF2-40B4-BE49-F238E27FC236}">
                <a16:creationId xmlns:a16="http://schemas.microsoft.com/office/drawing/2014/main" id="{3FEFC3AC-6994-F379-9787-39966F49824E}"/>
              </a:ext>
            </a:extLst>
          </p:cNvPr>
          <p:cNvSpPr txBox="1"/>
          <p:nvPr/>
        </p:nvSpPr>
        <p:spPr>
          <a:xfrm>
            <a:off x="5125216" y="795940"/>
            <a:ext cx="1592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RSH3</a:t>
            </a:r>
            <a:r>
              <a:rPr lang="it-IT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39-221</a:t>
            </a:r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AFDEBFA-B52D-78DB-946D-3ABBB7362A65}"/>
              </a:ext>
            </a:extLst>
          </p:cNvPr>
          <p:cNvSpPr/>
          <p:nvPr/>
        </p:nvSpPr>
        <p:spPr>
          <a:xfrm>
            <a:off x="3753042" y="3428999"/>
            <a:ext cx="1274394" cy="7273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4FE5754-4B2B-AA51-FD6A-C3E604D100DC}"/>
              </a:ext>
            </a:extLst>
          </p:cNvPr>
          <p:cNvSpPr/>
          <p:nvPr/>
        </p:nvSpPr>
        <p:spPr>
          <a:xfrm>
            <a:off x="5719271" y="3428999"/>
            <a:ext cx="652743" cy="7273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CasellaDiTesto 7">
            <a:extLst>
              <a:ext uri="{FF2B5EF4-FFF2-40B4-BE49-F238E27FC236}">
                <a16:creationId xmlns:a16="http://schemas.microsoft.com/office/drawing/2014/main" id="{CC15CBE8-7E7C-BBBF-8D81-082D87C7B134}"/>
              </a:ext>
            </a:extLst>
          </p:cNvPr>
          <p:cNvSpPr txBox="1"/>
          <p:nvPr/>
        </p:nvSpPr>
        <p:spPr>
          <a:xfrm>
            <a:off x="328670" y="365635"/>
            <a:ext cx="13321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>
                <a:latin typeface="Arial" panose="020B0604020202020204" pitchFamily="34" charset="0"/>
                <a:cs typeface="Arial" panose="020B0604020202020204" pitchFamily="34" charset="0"/>
              </a:rPr>
              <a:t>SDS Anti-GFP</a:t>
            </a:r>
          </a:p>
        </p:txBody>
      </p:sp>
    </p:spTree>
    <p:extLst>
      <p:ext uri="{BB962C8B-B14F-4D97-AF65-F5344CB8AC3E}">
        <p14:creationId xmlns:p14="http://schemas.microsoft.com/office/powerpoint/2010/main" val="139669864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Widescreen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</dc:creator>
  <cp:lastModifiedBy>FIELD Benjamin</cp:lastModifiedBy>
  <cp:revision>2</cp:revision>
  <dcterms:created xsi:type="dcterms:W3CDTF">2023-03-27T10:50:37Z</dcterms:created>
  <dcterms:modified xsi:type="dcterms:W3CDTF">2023-04-13T15:13:11Z</dcterms:modified>
</cp:coreProperties>
</file>